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72" d="100"/>
          <a:sy n="72" d="100"/>
        </p:scale>
        <p:origin x="57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738BFD-4EA8-4F91-8331-BA2B6307C40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839F4D4-B2F1-4FE0-94BF-606D0B110F1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AC3626-F069-475A-B95E-CAE97075F5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1D560-D7B3-4588-9672-179885302DC3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5A884A-0A3F-4959-9A86-77A89F9A0F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A16DA4-C9DD-458C-9A99-D74D022D0F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1591E-CD37-4C41-8A3C-80E30A868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40957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B71800-2186-4010-824C-E7E5137CE8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28B7A1D-F1BA-44E6-A0F7-BBFBCA6148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C485AB-00E4-487D-A0F2-06EAA58514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1D560-D7B3-4588-9672-179885302DC3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A4ACD2-3C16-4513-92F7-46B35C8F90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712DF0-E06E-4B48-AFE4-E78CCF7B38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1591E-CD37-4C41-8A3C-80E30A868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50744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C870EEB-589C-4EBC-8C7D-C68F40EE109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C003FA7-9829-4B67-8C20-AE17FC4082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BAA306-3B1F-4B0D-A282-8A405F3793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1D560-D7B3-4588-9672-179885302DC3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6A8E88-016E-40FC-9357-E5C2343B49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3AF610-FE2A-4D8F-9D53-D1E0ACF4A8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1591E-CD37-4C41-8A3C-80E30A868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84354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C651C5-B0EB-4101-8063-C039BB0A75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2C4A16-1BB9-4EF4-8463-594B0C19327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9D0242-F931-4DBE-AF4D-4623524C7C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1D560-D7B3-4588-9672-179885302DC3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308A1C-0B34-49DF-996B-E9E1670610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635ECD-43B9-474C-A6BD-31971D240F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1591E-CD37-4C41-8A3C-80E30A868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55576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134E12-8901-404C-B4BF-12BA0EE097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CDE9CFC-E197-43FF-86B4-DD0132F015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35AB15-17B6-4051-B657-681CD998A4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1D560-D7B3-4588-9672-179885302DC3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48D906-DC0A-469D-B6D2-03BFF024E7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D42B54-2481-4911-A68C-626956FCF9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1591E-CD37-4C41-8A3C-80E30A868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4551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6AE251-60C2-41F9-AE78-2804BA13C6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8B24B8-C4EF-4BEA-8059-A08AE21C59E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134F73B-E991-4C9A-8E60-736FA7DE97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4AE10BF-2BEB-434C-90BE-143B38D3B1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1D560-D7B3-4588-9672-179885302DC3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08A0FB2-E111-496E-84AD-D39FC2FABC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6EA14F-6A6B-4C4A-ADBC-11AB0AB075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1591E-CD37-4C41-8A3C-80E30A868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34989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8A45E0-10FA-4168-A3D6-53FD58A6F2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8EB8C2-531C-45FE-BD05-C316145C9C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9B4E7A-5864-4BFE-9486-B64A79DC62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4FD5FC2-25DA-4C31-99A4-381A355F725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EF9E05F-638E-4276-BCB7-2A2DFA261A4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275624D-9CB3-4598-A507-F9EE11177D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1D560-D7B3-4588-9672-179885302DC3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0ED3666-0ED6-41E3-A294-3980695F9E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0EA5C41-96A9-482E-9822-D374850D21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1591E-CD37-4C41-8A3C-80E30A868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03714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1776B7-3ACF-44BB-AB2C-0DB7799790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606B6F9-9AD7-4B24-8E9A-923F5BB2A4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1D560-D7B3-4588-9672-179885302DC3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D71F4DF-0194-40BB-9211-D76EC2305C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52ED4BA-81F2-463D-AF8D-577A889D07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1591E-CD37-4C41-8A3C-80E30A868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71188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E01622D-45CA-4646-B24C-F9B204A136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1D560-D7B3-4588-9672-179885302DC3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E7FCC27-C0CC-4714-9AAF-B6AC0A2370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5456D23-BAF4-47CE-BBF2-5F7B039CFF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1591E-CD37-4C41-8A3C-80E30A868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5509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A8A7DD-5094-4A37-BC70-CB11787D70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0796B0-FFA5-4342-B5E6-82E0908BC91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C7D5014-E228-48E0-8C87-582C9031CF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7995D6-281A-4391-A04A-8F5B3E9DB4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1D560-D7B3-4588-9672-179885302DC3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266A425-D815-4E18-BF93-C3D6C9F854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44D21D-87FC-4203-9F6A-3FA7BD6F6C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1591E-CD37-4C41-8A3C-80E30A868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23323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FAB79C-F9D3-4BF9-973E-9BCCC0D337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FEC63A6-DB6D-4A56-86ED-68EF7F8A8D2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997BC94-0714-4D89-801E-B2A2DE83F84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C7EA56F-BD7B-4842-B6BB-289503643E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1D560-D7B3-4588-9672-179885302DC3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C34CAC1-0C90-4D1A-A84E-19FF1D5831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9ABB3C-201B-4A3B-BBCE-C41B8A1E7D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1591E-CD37-4C41-8A3C-80E30A868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58080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7643502-FFF4-4382-9092-C5046CC4B4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8877AC-E817-4ACA-B5D4-6DE0E9CAFE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B0E90F-6B68-4FFD-A94D-E4540DCBF48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91D560-D7B3-4588-9672-179885302DC3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ABBD75-22B4-4409-8CE1-EF4E76FC1E6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8CE1DE-4510-4B9A-905B-0E07CFF3425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81591E-CD37-4C41-8A3C-80E30A868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14608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 descr="Green lights in the sky&#10;&#10;Description automatically generated with medium confidence">
            <a:extLst>
              <a:ext uri="{FF2B5EF4-FFF2-40B4-BE49-F238E27FC236}">
                <a16:creationId xmlns:a16="http://schemas.microsoft.com/office/drawing/2014/main" id="{57AC1BD4-69F2-4DC8-AD8A-EA7D05BAF79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6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770"/>
          <a:stretch/>
        </p:blipFill>
        <p:spPr>
          <a:xfrm>
            <a:off x="2429267" y="1126370"/>
            <a:ext cx="1574716" cy="1591056"/>
          </a:xfrm>
          <a:prstGeom prst="rect">
            <a:avLst/>
          </a:prstGeom>
        </p:spPr>
      </p:pic>
      <p:pic>
        <p:nvPicPr>
          <p:cNvPr id="15" name="Picture 14" descr="A picture containing green, night sky&#10;&#10;Description automatically generated">
            <a:extLst>
              <a:ext uri="{FF2B5EF4-FFF2-40B4-BE49-F238E27FC236}">
                <a16:creationId xmlns:a16="http://schemas.microsoft.com/office/drawing/2014/main" id="{D925F4AD-F500-4144-BF3D-C6D6EAADA5C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6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754"/>
          <a:stretch/>
        </p:blipFill>
        <p:spPr>
          <a:xfrm>
            <a:off x="4192895" y="1127086"/>
            <a:ext cx="1596275" cy="159105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8D0B32BD-645F-471C-93AF-995D232BEC7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4525" y="863397"/>
            <a:ext cx="1340604" cy="2194560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9B57A5A8-34EA-48B1-BC9F-30FAD17A624C}"/>
              </a:ext>
            </a:extLst>
          </p:cNvPr>
          <p:cNvSpPr txBox="1"/>
          <p:nvPr/>
        </p:nvSpPr>
        <p:spPr>
          <a:xfrm>
            <a:off x="547910" y="3885684"/>
            <a:ext cx="9000297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600"/>
              </a:spcAft>
            </a:pPr>
            <a:r>
              <a:rPr lang="en-US" b="1" i="1" dirty="0">
                <a:latin typeface="Times New Roman" panose="02020603050405020304" pitchFamily="18" charset="0"/>
                <a:ea typeface="Batang" panose="02030600000101010101" pitchFamily="18" charset="-127"/>
              </a:rPr>
              <a:t>Figure S1</a:t>
            </a:r>
            <a:r>
              <a:rPr lang="en-US" sz="1800" b="1" i="1" dirty="0">
                <a:effectLst/>
                <a:latin typeface="Times New Roman" panose="02020603050405020304" pitchFamily="18" charset="0"/>
                <a:ea typeface="Batang" panose="02030600000101010101" pitchFamily="18" charset="-127"/>
              </a:rPr>
              <a:t>. Autofluorescence comparison between ipsilateral and contralateral tissues in a CCI mouse model.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Batang" panose="02030600000101010101" pitchFamily="18" charset="-127"/>
              </a:rPr>
              <a:t>(A) Mice </a:t>
            </a:r>
            <a:r>
              <a:rPr lang="en-US" i="1" dirty="0">
                <a:latin typeface="Times New Roman" panose="02020603050405020304" pitchFamily="18" charset="0"/>
                <a:ea typeface="Batang" panose="02030600000101010101" pitchFamily="18" charset="-127"/>
              </a:rPr>
              <a:t>were injected vehicle, not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Batang" panose="02030600000101010101" pitchFamily="18" charset="-127"/>
              </a:rPr>
              <a:t> C153-RhoB-MLV particles, at 1 h and 4 h post-CCI and examined 5 h post injury. (B) The ipsilateral region </a:t>
            </a:r>
            <a:r>
              <a:rPr lang="en-US" i="1" dirty="0">
                <a:latin typeface="Times New Roman" panose="02020603050405020304" pitchFamily="18" charset="0"/>
                <a:ea typeface="Batang" panose="02030600000101010101" pitchFamily="18" charset="-127"/>
              </a:rPr>
              <a:t>showed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Batang" panose="02030600000101010101" pitchFamily="18" charset="-127"/>
              </a:rPr>
              <a:t> reduced fluorescence compared to the contralateral region (0.89 ± 0.4-fold (N = 6), p-value = 0.041). This is further evidence that the increased fluorescent signal found in all studies are due to the particles and not differences </a:t>
            </a:r>
            <a:r>
              <a:rPr lang="en-US" i="1" dirty="0">
                <a:latin typeface="Times New Roman" panose="02020603050405020304" pitchFamily="18" charset="0"/>
                <a:ea typeface="Batang" panose="02030600000101010101" pitchFamily="18" charset="-127"/>
              </a:rPr>
              <a:t>in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Batang" panose="02030600000101010101" pitchFamily="18" charset="-127"/>
              </a:rPr>
              <a:t>background between the tissues. Scale bar = 100 </a:t>
            </a:r>
            <a:r>
              <a:rPr lang="el-GR" sz="1800" i="1" dirty="0">
                <a:effectLst/>
                <a:latin typeface="Times New Roman" panose="02020603050405020304" pitchFamily="18" charset="0"/>
                <a:ea typeface="Batang" panose="02030600000101010101" pitchFamily="18" charset="-127"/>
              </a:rPr>
              <a:t>μ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Batang" panose="02030600000101010101" pitchFamily="18" charset="-127"/>
              </a:rPr>
              <a:t>m.</a:t>
            </a:r>
            <a:endParaRPr lang="en-US" sz="1800" dirty="0">
              <a:effectLst/>
              <a:latin typeface="Times New Roman" panose="02020603050405020304" pitchFamily="18" charset="0"/>
              <a:ea typeface="Batang" panose="02030600000101010101" pitchFamily="18" charset="-127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60D7540-2526-43F2-91D0-14AFFE605BF9}"/>
              </a:ext>
            </a:extLst>
          </p:cNvPr>
          <p:cNvSpPr txBox="1"/>
          <p:nvPr/>
        </p:nvSpPr>
        <p:spPr>
          <a:xfrm>
            <a:off x="2415915" y="775808"/>
            <a:ext cx="16122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Ipsilatera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D0CDB68-3392-45E3-B469-44F0D2626612}"/>
              </a:ext>
            </a:extLst>
          </p:cNvPr>
          <p:cNvSpPr txBox="1"/>
          <p:nvPr/>
        </p:nvSpPr>
        <p:spPr>
          <a:xfrm>
            <a:off x="4208278" y="771702"/>
            <a:ext cx="15834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ontralatera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5774016-3F0C-461B-9EFC-72EA92D258A8}"/>
              </a:ext>
            </a:extLst>
          </p:cNvPr>
          <p:cNvSpPr txBox="1"/>
          <p:nvPr/>
        </p:nvSpPr>
        <p:spPr>
          <a:xfrm>
            <a:off x="1811292" y="768162"/>
            <a:ext cx="38277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418E416-E283-4C2D-9914-0FE98B6E0C91}"/>
              </a:ext>
            </a:extLst>
          </p:cNvPr>
          <p:cNvSpPr txBox="1"/>
          <p:nvPr/>
        </p:nvSpPr>
        <p:spPr>
          <a:xfrm>
            <a:off x="6001718" y="768162"/>
            <a:ext cx="38277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1721AFFF-5490-4E78-9C9C-C8FD46E32A41}"/>
              </a:ext>
            </a:extLst>
          </p:cNvPr>
          <p:cNvCxnSpPr/>
          <p:nvPr/>
        </p:nvCxnSpPr>
        <p:spPr>
          <a:xfrm>
            <a:off x="3502093" y="2572535"/>
            <a:ext cx="34747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C9E99CF7-34BA-4A9F-B474-D3D1F6D44626}"/>
              </a:ext>
            </a:extLst>
          </p:cNvPr>
          <p:cNvCxnSpPr/>
          <p:nvPr/>
        </p:nvCxnSpPr>
        <p:spPr>
          <a:xfrm>
            <a:off x="5272279" y="2574210"/>
            <a:ext cx="34747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922029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068</TotalTime>
  <Words>107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cky Whitener</dc:creator>
  <cp:lastModifiedBy>Jesus Diaz de Leon</cp:lastModifiedBy>
  <cp:revision>68</cp:revision>
  <dcterms:created xsi:type="dcterms:W3CDTF">2021-07-09T21:43:09Z</dcterms:created>
  <dcterms:modified xsi:type="dcterms:W3CDTF">2022-01-31T23:15:45Z</dcterms:modified>
</cp:coreProperties>
</file>